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05"/>
    <p:restoredTop sz="94786"/>
  </p:normalViewPr>
  <p:slideViewPr>
    <p:cSldViewPr snapToGrid="0">
      <p:cViewPr varScale="1">
        <p:scale>
          <a:sx n="115" d="100"/>
          <a:sy n="115" d="100"/>
        </p:scale>
        <p:origin x="129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462598-057A-4247-AF6A-F48B69E6E6E5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79BC7A-EEBE-154C-993F-999A7849B86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3786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5D9F44-DF88-747C-3BE5-6E5DAF46338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DE4EE2A0-6688-8A68-DCC1-EC503492FE5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D81C38D1-2A22-6B77-E79A-A09DC4AD6EE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CB9E78A-FE58-C7E3-7A47-C9553FFDE3E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F79BC7A-EEBE-154C-993F-999A7849B86F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37864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9A375D1-DA2C-F722-BBBC-0F8C75ABE0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1134A26-5F24-A7FB-9731-C541590A0D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EFE7454-F3A4-67D5-FE99-7B69B02E2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3C8CE32-A12A-487A-8FBC-BE251FE60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53E9107-0241-FF87-D829-715450F2E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7264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737FE26-66F6-EA1D-DEE6-B8C71C60BE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58F586C-A574-D9D9-B0B6-64843128DF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C3A9651-E7E9-4EE4-5892-5F409968A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320D0D-57D1-BF30-7D28-2A0BB83829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24C8D6-D548-32C7-BCE8-34D391D88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5115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12E29D4F-9C1A-C55C-7D04-E48FF8BA41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B44F4F6-5D6E-1D15-D6D3-DA23049ECF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748D165-813C-3D66-FA75-5E7D5D326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F6C9238-1C57-A1CA-1C73-16B319002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ECD00BE-7A83-8D12-0C5B-86C9B7B12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278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4EB66C3-3E72-3647-8F48-2522CEC2F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636C1F9-1A8F-A055-8B26-40E54A842A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44AA769-EDB5-2369-13B4-CEFDCD065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E14D8FE-B235-A813-8612-6CC5F2765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646ABBF-9E49-12DA-5DC4-AFC88AA18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9654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E44F2B-EE22-4718-B947-DD35E0C4F7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D36857B-523B-C7CD-7A26-E78B889C5E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22319FF-F0E3-9DA2-A31A-E4557EC51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6B166AE-667E-CB14-BD46-CEB2A441F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2F496D1-BF7C-F191-8BC8-7DC93F935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8620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7073A9-6B24-3D04-968F-83B6F61A17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C1D5E70-A95A-522D-38B6-DC57994B1C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098F61F-244A-9AD0-6B17-845484ADE1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D1F119-80DD-1B98-CEAE-42E21CD29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E684BE9-E3F7-796B-EF42-76A6CA513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AF0F79A-C7C2-0B21-8155-204F08982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1329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171D23C-D1CA-FF27-1E38-22F611E6DA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AB62A50-8548-B0AC-438D-10097404E2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1582AC1-CF6D-D150-FB8F-49DA1E9E3D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DF1754D-F519-2FC3-C6E3-FB2074285D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C5CC4E2-1A32-653F-C98F-2EDAAFA259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6765C97-5DB9-C9E9-1E2B-51CD2355A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E19B263-A189-3BF0-91DF-4DB0A8EA60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AF55CA5A-58C7-2D5E-904A-3256BA099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932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42B14C-8B5F-9C47-8FE6-81C9ABFA22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6AC3551-1147-7A4D-9BCB-B423EE334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C4C247F-F94F-7C8E-244E-ACC1A4556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C203015-BE2C-21F1-CB75-AC5E64BED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9814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B336931D-BBB9-CA48-5107-B50B767D9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F768022F-F298-AC6E-6DB6-855F1AD5B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91C6DDF-C33F-D846-EB06-AF256359D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5385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81C0B0D-5566-3894-2449-080B21BCD4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975B1D6-FA15-BA13-2EC8-2E83869ECA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30C14EE-F583-E9FB-9FA8-C8D68448BE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47EA67A-AFBB-7F11-7DD0-ED74D2281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C417DA6-A030-3BF3-94D6-644EF6384D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B9374A6-8BBF-A0D4-B187-6EEBA8961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7444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C3AE7D3-7E89-98BE-557F-594B84790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301B35C-9259-4E95-F6D4-62781AFA28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11121EA-B8D3-44C0-5B0F-3A7F7248B8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C892DF5-8A0F-0D11-3A6D-573E04852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7680DB0-8408-672A-F581-49D420B7B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A11E5CC-6E85-ACF0-3481-2ABF83B379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1286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F20D9B9-D36A-7AFE-949F-05B17F6530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BB4C774-2523-C2DB-FF45-77EA880BFC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468576F-A8F5-826A-4018-AD72377A2D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BD5CEF-058D-9041-BAAA-4729311F7EF4}" type="datetimeFigureOut">
              <a:rPr lang="fr-FR" smtClean="0"/>
              <a:t>14/1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0BCC43C-30E6-1D66-D843-1FA7D40ACF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6DE85C9-CA86-EA15-A6A3-3F64145CCD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2B29A49-CBC9-A140-9F74-26EA5EF98C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7973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7DB3F4-F576-9646-9F23-E8EED0CAA2E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>
            <a:extLst>
              <a:ext uri="{FF2B5EF4-FFF2-40B4-BE49-F238E27FC236}">
                <a16:creationId xmlns:a16="http://schemas.microsoft.com/office/drawing/2014/main" id="{C77E6FE3-248F-9B91-6508-BF9E9EA7F70A}"/>
              </a:ext>
            </a:extLst>
          </p:cNvPr>
          <p:cNvSpPr txBox="1"/>
          <p:nvPr/>
        </p:nvSpPr>
        <p:spPr>
          <a:xfrm rot="19839314">
            <a:off x="3296039" y="5300618"/>
            <a:ext cx="925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May 2022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255939F5-9AD8-477A-6599-4D542F5DECB0}"/>
              </a:ext>
            </a:extLst>
          </p:cNvPr>
          <p:cNvSpPr txBox="1"/>
          <p:nvPr/>
        </p:nvSpPr>
        <p:spPr>
          <a:xfrm rot="19839314">
            <a:off x="4204221" y="5339006"/>
            <a:ext cx="931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July  2022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2AF8168E-2B50-BE10-D408-08F2217BA696}"/>
              </a:ext>
            </a:extLst>
          </p:cNvPr>
          <p:cNvSpPr txBox="1"/>
          <p:nvPr/>
        </p:nvSpPr>
        <p:spPr>
          <a:xfrm rot="19839314">
            <a:off x="5077567" y="5231284"/>
            <a:ext cx="12636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/>
              <a:t>November</a:t>
            </a:r>
            <a:r>
              <a:rPr lang="fr-FR" sz="1400" dirty="0"/>
              <a:t>  2022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7966697E-89F4-DC08-3073-D967F0999590}"/>
              </a:ext>
            </a:extLst>
          </p:cNvPr>
          <p:cNvSpPr txBox="1"/>
          <p:nvPr/>
        </p:nvSpPr>
        <p:spPr>
          <a:xfrm rot="19839314">
            <a:off x="6300254" y="5259553"/>
            <a:ext cx="10789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/>
              <a:t>February</a:t>
            </a:r>
            <a:r>
              <a:rPr lang="fr-FR" sz="1400" dirty="0"/>
              <a:t> 2023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D657902C-7FD3-D3EF-4198-2287C761D7DE}"/>
              </a:ext>
            </a:extLst>
          </p:cNvPr>
          <p:cNvSpPr txBox="1"/>
          <p:nvPr/>
        </p:nvSpPr>
        <p:spPr>
          <a:xfrm rot="19839314">
            <a:off x="7447417" y="5331489"/>
            <a:ext cx="925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May 2023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F2B4A6C0-2649-CFE1-20D2-904B84F641FC}"/>
              </a:ext>
            </a:extLst>
          </p:cNvPr>
          <p:cNvSpPr txBox="1"/>
          <p:nvPr/>
        </p:nvSpPr>
        <p:spPr>
          <a:xfrm rot="19839314">
            <a:off x="8450192" y="5223767"/>
            <a:ext cx="9964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August 2023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177A8D2E-B6AA-5C29-9427-CF03C650AF44}"/>
              </a:ext>
            </a:extLst>
          </p:cNvPr>
          <p:cNvSpPr txBox="1"/>
          <p:nvPr/>
        </p:nvSpPr>
        <p:spPr>
          <a:xfrm rot="19839314">
            <a:off x="9543382" y="5239203"/>
            <a:ext cx="106698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/>
              <a:t>December</a:t>
            </a:r>
            <a:r>
              <a:rPr lang="fr-FR" sz="1400" dirty="0"/>
              <a:t> 2023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1936136E-9235-2256-7208-C7B8A2190C9F}"/>
              </a:ext>
            </a:extLst>
          </p:cNvPr>
          <p:cNvSpPr txBox="1"/>
          <p:nvPr/>
        </p:nvSpPr>
        <p:spPr>
          <a:xfrm>
            <a:off x="1784194" y="5736178"/>
            <a:ext cx="962350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u="sng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Data Table S1</a:t>
            </a:r>
            <a:r>
              <a:rPr lang="en-US" sz="1600" b="1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1600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lusion period for the 15 mycology laboratories involved in the Recap “Resistance of </a:t>
            </a:r>
            <a:r>
              <a:rPr lang="en-US" sz="1600" i="1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a parapsilosis </a:t>
            </a:r>
            <a:r>
              <a:rPr lang="en-US" sz="1600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azole drugs”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y.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hatched bars correspond to laboratories in the Paris region. The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étei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Henri Mondor laboratory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s the activities of three separate centers.</a:t>
            </a:r>
            <a:endParaRPr lang="en-US" sz="1600" noProof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7A914886-586E-9DC2-4325-C460C6CC76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0718" y="34772"/>
            <a:ext cx="10230563" cy="50955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065996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67</Words>
  <Application>Microsoft Macintosh PowerPoint</Application>
  <PresentationFormat>Grand écran</PresentationFormat>
  <Paragraphs>10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rnaud Fekkar</dc:creator>
  <cp:lastModifiedBy>Arnaud Fekkar</cp:lastModifiedBy>
  <cp:revision>6</cp:revision>
  <dcterms:created xsi:type="dcterms:W3CDTF">2025-10-21T08:07:33Z</dcterms:created>
  <dcterms:modified xsi:type="dcterms:W3CDTF">2025-11-14T21:39:44Z</dcterms:modified>
</cp:coreProperties>
</file>